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DD9A5A-958D-4337-8FAA-E2CAB34663BA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73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ure E1. Flow Diagram Showing Study Design and Recruit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A6D939-D4F1-4A36-9591-70045BB0B871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624725-7CDE-4983-BDE4-C979EDF50C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D20E09-C72B-4397-B928-7A890A2DE6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0590F3-4163-4CE3-8DD7-3C6C9D893E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876FF1-22A4-4641-A677-FAAC8FA291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918486-B8A7-4393-A324-84B020A50F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59A3D6-34CD-4321-8C1B-ABA9C64C8B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597DB5-3E46-4678-A6CE-078AD4CCF5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9CAEEF-6A9E-43FC-9897-F7455B1B84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7C9F16-75D1-4A42-9002-B1449E91CB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AA0558-5E7F-4404-B88B-4BDEA7EB3C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7F8F83-6215-4878-A6E2-2D8C4A7DE8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65B40F-11CF-4A11-9003-8334909F0E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8B979A-189B-4277-A6A7-02BD5A0052C4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"/>
          <p:cNvGrpSpPr/>
          <p:nvPr/>
        </p:nvGrpSpPr>
        <p:grpSpPr>
          <a:xfrm>
            <a:off x="375120" y="633240"/>
            <a:ext cx="8143200" cy="5498640"/>
            <a:chOff x="375120" y="633240"/>
            <a:chExt cx="8143200" cy="5498640"/>
          </a:xfrm>
        </p:grpSpPr>
        <p:sp>
          <p:nvSpPr>
            <p:cNvPr id="49" name="TextBox 3"/>
            <p:cNvSpPr/>
            <p:nvPr/>
          </p:nvSpPr>
          <p:spPr>
            <a:xfrm>
              <a:off x="2131560" y="633240"/>
              <a:ext cx="2546280" cy="246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7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sented and assessed for eligibilit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5"/>
            <p:cNvSpPr/>
            <p:nvPr/>
          </p:nvSpPr>
          <p:spPr>
            <a:xfrm>
              <a:off x="4602240" y="1129320"/>
              <a:ext cx="3916080" cy="8553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xcluded: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</a:t>
              </a: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d not meet inclusion criter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</a:t>
              </a: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egative methacholine challenge test (presumed asthmatic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</a:t>
              </a: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ositive skin prick testing (healthy control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</a:t>
              </a: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vestigator judgement: on ciclosporin therap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6"/>
            <p:cNvSpPr/>
            <p:nvPr/>
          </p:nvSpPr>
          <p:spPr>
            <a:xfrm>
              <a:off x="2991600" y="2363400"/>
              <a:ext cx="833040" cy="246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8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clud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7"/>
            <p:cNvSpPr/>
            <p:nvPr/>
          </p:nvSpPr>
          <p:spPr>
            <a:xfrm>
              <a:off x="4397400" y="2756880"/>
              <a:ext cx="2068920" cy="246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scontinued: participant choic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8"/>
            <p:cNvSpPr/>
            <p:nvPr/>
          </p:nvSpPr>
          <p:spPr>
            <a:xfrm>
              <a:off x="2758680" y="3294360"/>
              <a:ext cx="1303920" cy="246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6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mpleted stud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11"/>
            <p:cNvSpPr/>
            <p:nvPr/>
          </p:nvSpPr>
          <p:spPr>
            <a:xfrm>
              <a:off x="2669400" y="3906720"/>
              <a:ext cx="1483920" cy="246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6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linical phenotypin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13"/>
            <p:cNvSpPr/>
            <p:nvPr/>
          </p:nvSpPr>
          <p:spPr>
            <a:xfrm>
              <a:off x="2736360" y="4523760"/>
              <a:ext cx="1329840" cy="246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4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utum induc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4"/>
            <p:cNvSpPr/>
            <p:nvPr/>
          </p:nvSpPr>
          <p:spPr>
            <a:xfrm>
              <a:off x="2756880" y="5097960"/>
              <a:ext cx="1299240" cy="246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onchoscopy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15"/>
            <p:cNvSpPr/>
            <p:nvPr/>
          </p:nvSpPr>
          <p:spPr>
            <a:xfrm>
              <a:off x="375120" y="5885640"/>
              <a:ext cx="1198800" cy="246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althy 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16"/>
            <p:cNvSpPr/>
            <p:nvPr/>
          </p:nvSpPr>
          <p:spPr>
            <a:xfrm>
              <a:off x="1985760" y="5877000"/>
              <a:ext cx="1035720" cy="246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ild asthm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17"/>
            <p:cNvSpPr/>
            <p:nvPr/>
          </p:nvSpPr>
          <p:spPr>
            <a:xfrm>
              <a:off x="3410640" y="5877000"/>
              <a:ext cx="1339200" cy="246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3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derate asthm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18"/>
            <p:cNvSpPr/>
            <p:nvPr/>
          </p:nvSpPr>
          <p:spPr>
            <a:xfrm>
              <a:off x="5131080" y="5877000"/>
              <a:ext cx="1206360" cy="246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2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evere asthm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1" name="Elbow Connector 26"/>
            <p:cNvCxnSpPr>
              <a:stCxn id="49" idx="2"/>
              <a:endCxn id="51" idx="0"/>
            </p:cNvCxnSpPr>
            <p:nvPr/>
          </p:nvCxnSpPr>
          <p:spPr>
            <a:xfrm flipH="1" rot="16200000">
              <a:off x="2664360" y="1619640"/>
              <a:ext cx="1484280" cy="3960"/>
            </a:xfrm>
            <a:prstGeom prst="bentConnector3">
              <a:avLst>
                <a:gd name="adj1" fmla="val 50024"/>
              </a:avLst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2" name="Elbow Connector 28"/>
            <p:cNvCxnSpPr>
              <a:stCxn id="49" idx="2"/>
              <a:endCxn id="50" idx="1"/>
            </p:cNvCxnSpPr>
            <p:nvPr/>
          </p:nvCxnSpPr>
          <p:spPr>
            <a:xfrm flipH="1" rot="16200000">
              <a:off x="3664440" y="619200"/>
              <a:ext cx="677880" cy="1198080"/>
            </a:xfrm>
            <a:prstGeom prst="bentConnector2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3" name="Elbow Connector 30"/>
            <p:cNvCxnSpPr>
              <a:stCxn id="51" idx="2"/>
              <a:endCxn id="53" idx="0"/>
            </p:cNvCxnSpPr>
            <p:nvPr/>
          </p:nvCxnSpPr>
          <p:spPr>
            <a:xfrm flipH="1" rot="16200000">
              <a:off x="3066840" y="2950560"/>
              <a:ext cx="685080" cy="2880"/>
            </a:xfrm>
            <a:prstGeom prst="bentConnector3">
              <a:avLst>
                <a:gd name="adj1" fmla="val 50052"/>
              </a:avLst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4" name="Elbow Connector 32"/>
            <p:cNvCxnSpPr>
              <a:stCxn id="51" idx="2"/>
              <a:endCxn id="52" idx="1"/>
            </p:cNvCxnSpPr>
            <p:nvPr/>
          </p:nvCxnSpPr>
          <p:spPr>
            <a:xfrm flipH="1" rot="16200000">
              <a:off x="3767760" y="2250000"/>
              <a:ext cx="270720" cy="989640"/>
            </a:xfrm>
            <a:prstGeom prst="bentConnector2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5" name="Elbow Connector 34"/>
            <p:cNvCxnSpPr>
              <a:stCxn id="53" idx="2"/>
              <a:endCxn id="54" idx="0"/>
            </p:cNvCxnSpPr>
            <p:nvPr/>
          </p:nvCxnSpPr>
          <p:spPr>
            <a:xfrm flipH="1" rot="16200000">
              <a:off x="3228120" y="3723120"/>
              <a:ext cx="366480" cy="1080"/>
            </a:xfrm>
            <a:prstGeom prst="bentConnector3">
              <a:avLst>
                <a:gd name="adj1" fmla="val 50049"/>
              </a:avLst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6" name="Elbow Connector 42"/>
            <p:cNvCxnSpPr>
              <a:stCxn id="54" idx="2"/>
              <a:endCxn id="55" idx="0"/>
            </p:cNvCxnSpPr>
            <p:nvPr/>
          </p:nvCxnSpPr>
          <p:spPr>
            <a:xfrm rot="5400000">
              <a:off x="3220920" y="4333320"/>
              <a:ext cx="371160" cy="10440"/>
            </a:xfrm>
            <a:prstGeom prst="bentConnector3">
              <a:avLst>
                <a:gd name="adj1" fmla="val 50097"/>
              </a:avLst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7" name="Elbow Connector 46"/>
            <p:cNvCxnSpPr>
              <a:stCxn id="55" idx="2"/>
              <a:endCxn id="56" idx="0"/>
            </p:cNvCxnSpPr>
            <p:nvPr/>
          </p:nvCxnSpPr>
          <p:spPr>
            <a:xfrm flipH="1" rot="16200000">
              <a:off x="3240000" y="4931280"/>
              <a:ext cx="328320" cy="5400"/>
            </a:xfrm>
            <a:prstGeom prst="bentConnector3">
              <a:avLst>
                <a:gd name="adj1" fmla="val 50054"/>
              </a:avLst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8" name="Elbow Connector 48"/>
            <p:cNvCxnSpPr>
              <a:stCxn id="56" idx="2"/>
              <a:endCxn id="57" idx="0"/>
            </p:cNvCxnSpPr>
            <p:nvPr/>
          </p:nvCxnSpPr>
          <p:spPr>
            <a:xfrm rot="5400000">
              <a:off x="1919520" y="4399200"/>
              <a:ext cx="541800" cy="2432160"/>
            </a:xfrm>
            <a:prstGeom prst="bentConnector3">
              <a:avLst>
                <a:gd name="adj1" fmla="val 50000"/>
              </a:avLst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69" name="Elbow Connector 50"/>
            <p:cNvCxnSpPr>
              <a:stCxn id="56" idx="2"/>
              <a:endCxn id="58" idx="0"/>
            </p:cNvCxnSpPr>
            <p:nvPr/>
          </p:nvCxnSpPr>
          <p:spPr>
            <a:xfrm rot="5400000">
              <a:off x="2688480" y="5159160"/>
              <a:ext cx="533160" cy="903240"/>
            </a:xfrm>
            <a:prstGeom prst="bentConnector3">
              <a:avLst>
                <a:gd name="adj1" fmla="val 50000"/>
              </a:avLst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70" name="Elbow Connector 52"/>
            <p:cNvCxnSpPr>
              <a:stCxn id="56" idx="2"/>
              <a:endCxn id="59" idx="0"/>
            </p:cNvCxnSpPr>
            <p:nvPr/>
          </p:nvCxnSpPr>
          <p:spPr>
            <a:xfrm flipH="1" rot="16200000">
              <a:off x="3476880" y="5273640"/>
              <a:ext cx="533160" cy="674280"/>
            </a:xfrm>
            <a:prstGeom prst="bentConnector3">
              <a:avLst>
                <a:gd name="adj1" fmla="val 50000"/>
              </a:avLst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71" name="Elbow Connector 54"/>
            <p:cNvCxnSpPr>
              <a:stCxn id="56" idx="2"/>
              <a:endCxn id="60" idx="0"/>
            </p:cNvCxnSpPr>
            <p:nvPr/>
          </p:nvCxnSpPr>
          <p:spPr>
            <a:xfrm flipH="1" rot="16200000">
              <a:off x="4303800" y="4446720"/>
              <a:ext cx="533160" cy="2328120"/>
            </a:xfrm>
            <a:prstGeom prst="bentConnector3">
              <a:avLst>
                <a:gd name="adj1" fmla="val 50000"/>
              </a:avLst>
            </a:prstGeom>
            <a:ln w="9360">
              <a:solidFill>
                <a:srgbClr val="000000"/>
              </a:solidFill>
              <a:miter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3T13:19:05Z</dcterms:created>
  <dc:creator>Hinks T.</dc:creator>
  <dc:description/>
  <dc:language>en-US</dc:language>
  <cp:lastModifiedBy>Hinks T.</cp:lastModifiedBy>
  <cp:lastPrinted>2013-09-25T09:00:55Z</cp:lastPrinted>
  <dcterms:modified xsi:type="dcterms:W3CDTF">2014-06-23T21:46:03Z</dcterms:modified>
  <cp:revision>272</cp:revision>
  <dc:subject/>
  <dc:title>PowerPoint Presentation</dc:title>
</cp:coreProperties>
</file>